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F60304-5C42-4650-9019-663356B94BDE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B7E59F-4176-4AE0-B7D8-5113F504D21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72444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Z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B7E59F-4176-4AE0-B7D8-5113F504D217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431818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118C0-B743-4880-B0D1-D76F00561E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132B07-AAF5-4459-BFEF-2B1CFB6F12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8BC31A-9581-4198-BD99-67D15193D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B96874-7735-4C06-AFB5-5BD4F4B97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12FA8A-8CDF-4F81-80EA-BCA0E2DB1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8095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9187C0-DDFA-46FC-B388-1071810ABC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9A80F2-12F3-4BB3-8CEA-064730F748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E75E46-8F7A-4328-980C-964EE4717E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5F380B-0182-4076-8FF5-48A92781B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F9B784-1990-4C5E-AD63-0ABEA9E1F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96932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4D912F-67C3-40D6-BBAD-359BA8EC53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882F8C-B2A5-4398-BDF3-B6FC51B86A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6E7A9D-3AF1-479E-8BEC-C299E4503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CB20B7-1ED6-4AD2-99B2-227D9F24A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1BB7D7-5869-4D75-976F-C32404D84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93012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1E482-0B1C-4109-87D0-96F892FA6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1B7C48-3566-4233-B443-8EC81F42AD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3D28CF-9ACD-4D64-A65D-66DBF746A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960C31-7DE8-47A9-98D9-55D20F9EB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1AB0CB-154A-452F-9675-2234B38B3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14741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30E35-2262-41C9-81E7-655C517AFD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937BC3-9EEE-482D-A5AF-A89EC71277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5FC2B4-873F-4B90-915F-98902E12A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E42545-8FDC-4814-802F-E51F90C30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446AB6-A584-49B2-9D00-3E8894AC1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07452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B1548-4052-4F01-AA58-84C73F998B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A16079-5B19-4B2A-9F4E-21BAA41719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05915E-4141-4C76-BF8A-E4A4CED8AC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104DDD-0D5A-4045-A551-D383C3D3E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F377F5-0433-46AB-9083-96FC1570A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6992BA-6ED7-4B4E-B805-4E6EAFD1D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23690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95BE21-D855-40FF-B0DD-5D651BF4A8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D90802-6501-4278-B7C0-2BF98EDF4E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82BE10-3AE5-40E6-A3EE-0335F92B67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24BF50-46AE-4EFB-8A11-27878EE8F9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410EEA-9E71-42AA-A77C-438D1FB550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C076E9-B5AA-48B7-850B-F2A95776A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8CB4E90-ED03-4D61-99EC-A95CDC36E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5C75ED-496A-4D03-9CEB-13542652D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84652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CBFF64-CE0D-40D2-9DD8-C6DD2F442B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72CEE4-48AE-46FF-8F75-5F613084F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2341DBC-F228-427B-A113-C19308B74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A1B9DA-AAC8-4550-93BE-D22733B68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37832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FF5F75-48B4-4E6F-AA49-4BAE67583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7C651E-E33D-4713-A88C-A12CC7521B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32E365-D9C3-4492-9BF0-4B89BA107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84859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1911E2-BEBC-4374-9835-963E8FC3ED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8306A9-666C-4733-8540-F0CADDE825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554DC6-09F1-4F5D-8C38-122BA335B3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53A6C6-4D4F-48CE-B631-87F800616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4A082D-F2B7-4994-9A60-00988C5BB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28995C-A77E-4D54-BE7A-49FAAEE0A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30273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C764B0-84A7-4DA4-A15E-FF5B8C9A0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EB7224-A0B3-46BB-BFB8-49CDE841C2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B16A41-1F83-42FB-A204-584E847A87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289D6D-1736-4689-B22B-406435AE6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C46C44-FF52-4F64-ABFF-E5D6F0263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371FAA-D2E9-4B4C-8A12-FB181A0D4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19210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700D40-C7EC-4DD3-9F60-02F98776B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9DBF09-2D23-41C9-B4BA-FEF7B7EB76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819960-848D-473F-9C0D-CF415D8822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87F71-51F1-4555-B861-2030264A4E5F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F18CB0-39CD-443D-A128-32F05387AA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E74F1B-92BB-4E44-A6E1-C9C2E9FE4A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6DA7CE-C05D-49F9-A15A-E7B788AF1F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06330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7AC99988-B089-0095-C272-1E795A0D07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5422" y="0"/>
            <a:ext cx="10919534" cy="614223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1460A1E-177E-1D3D-BCF3-DB7E69E773D7}"/>
              </a:ext>
            </a:extLst>
          </p:cNvPr>
          <p:cNvSpPr txBox="1"/>
          <p:nvPr/>
        </p:nvSpPr>
        <p:spPr>
          <a:xfrm>
            <a:off x="426128" y="6214369"/>
            <a:ext cx="114877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7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The relative expression of protein coding genes of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uchnera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hidicola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ZA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Dn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plotted over their %GC content and protein identity towards 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scherichia coli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tr. K12. High expression genes </a:t>
            </a:r>
            <a:r>
              <a:rPr lang="en-ZA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gCPM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gt; 12; Mid expression genes </a:t>
            </a:r>
            <a:r>
              <a:rPr lang="en-ZA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gCPM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12 and &gt; 9; Low expression </a:t>
            </a:r>
            <a:r>
              <a:rPr lang="en-ZA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gCPM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9.</a:t>
            </a:r>
          </a:p>
        </p:txBody>
      </p:sp>
    </p:spTree>
    <p:extLst>
      <p:ext uri="{BB962C8B-B14F-4D97-AF65-F5344CB8AC3E}">
        <p14:creationId xmlns:p14="http://schemas.microsoft.com/office/powerpoint/2010/main" val="4014823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5</TotalTime>
  <Words>58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ger, Francois, Mnr [nfvburger@sun.ac.za]</dc:creator>
  <cp:lastModifiedBy>Oberholster, A, Prof [ambo@sun.ac.za]</cp:lastModifiedBy>
  <cp:revision>24</cp:revision>
  <dcterms:created xsi:type="dcterms:W3CDTF">2022-02-16T17:06:32Z</dcterms:created>
  <dcterms:modified xsi:type="dcterms:W3CDTF">2024-01-17T12:39:22Z</dcterms:modified>
</cp:coreProperties>
</file>